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73" r:id="rId2"/>
    <p:sldId id="262" r:id="rId3"/>
    <p:sldId id="274" r:id="rId4"/>
    <p:sldId id="268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B7DF0"/>
    <a:srgbClr val="B87AB2"/>
    <a:srgbClr val="9E9AC8"/>
    <a:srgbClr val="67A9CF"/>
    <a:srgbClr val="B0B0B4"/>
    <a:srgbClr val="077E97"/>
    <a:srgbClr val="0BBC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2712" y="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81C04F1-0DEC-4494-8957-65B5A95D464C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2A20A34-619B-40DD-A0F5-481ADC4ED7BB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2112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76373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62152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6290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43825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143404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9487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1991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3424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1639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60925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913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5D50AD3-9E73-4557-8942-9695744BBDA6}" type="datetimeFigureOut">
              <a:rPr lang="es-ES" smtClean="0"/>
              <a:t>19/05/20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CF142F5-7144-4CF5-89C4-5844C0191DF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4524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7" Type="http://schemas.openxmlformats.org/officeDocument/2006/relationships/image" Target="../media/image11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6.tiff"/><Relationship Id="rId5" Type="http://schemas.openxmlformats.org/officeDocument/2006/relationships/image" Target="../media/image15.tiff"/><Relationship Id="rId4" Type="http://schemas.openxmlformats.org/officeDocument/2006/relationships/image" Target="../media/image14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Interfaz de usuario gráfica">
            <a:extLst>
              <a:ext uri="{FF2B5EF4-FFF2-40B4-BE49-F238E27FC236}">
                <a16:creationId xmlns:a16="http://schemas.microsoft.com/office/drawing/2014/main" id="{9C1BE119-6E06-BE0D-9B96-BB80CF1C6C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9336" y="991426"/>
            <a:ext cx="4627463" cy="5322968"/>
          </a:xfrm>
          <a:prstGeom prst="rect">
            <a:avLst/>
          </a:prstGeom>
        </p:spPr>
      </p:pic>
      <p:sp>
        <p:nvSpPr>
          <p:cNvPr id="6" name="38 CuadroTexto">
            <a:extLst>
              <a:ext uri="{FF2B5EF4-FFF2-40B4-BE49-F238E27FC236}">
                <a16:creationId xmlns:a16="http://schemas.microsoft.com/office/drawing/2014/main" id="{3B2801F9-49E9-43CA-0DC4-00FF95AC2F5E}"/>
              </a:ext>
            </a:extLst>
          </p:cNvPr>
          <p:cNvSpPr txBox="1"/>
          <p:nvPr/>
        </p:nvSpPr>
        <p:spPr>
          <a:xfrm>
            <a:off x="554881" y="641799"/>
            <a:ext cx="575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898D63F0-7B14-93D5-A1B2-85B4E8120A3A}"/>
              </a:ext>
            </a:extLst>
          </p:cNvPr>
          <p:cNvSpPr txBox="1"/>
          <p:nvPr/>
        </p:nvSpPr>
        <p:spPr>
          <a:xfrm>
            <a:off x="564406" y="6477000"/>
            <a:ext cx="574454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1. Workflow of the study design. 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D, atopic dermatitis; CLA, cutaneous lymphocyte-associated antigen; Epi, epidermal cells; HDM, house dust mite; H&amp;E, hematoxylin and eosin; PBMCs, peripheral blood mononuclear cells; SEB, staphylococcal enterotoxin B; Tm, memory T cells. This figure was created using images under a Creative Commons license.</a:t>
            </a:r>
            <a:endParaRPr lang="es-ES" sz="105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78543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BDDEB70B-6439-E6C8-1B8B-49ECE909815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20233" y="1295354"/>
            <a:ext cx="1948654" cy="1908000"/>
          </a:xfrm>
          <a:prstGeom prst="rect">
            <a:avLst/>
          </a:prstGeom>
        </p:spPr>
      </p:pic>
      <p:pic>
        <p:nvPicPr>
          <p:cNvPr id="7" name="Imagen 6" descr="Gráfico, Gráfico de dispersión&#10;&#10;Descripción generada automáticamente">
            <a:extLst>
              <a:ext uri="{FF2B5EF4-FFF2-40B4-BE49-F238E27FC236}">
                <a16:creationId xmlns:a16="http://schemas.microsoft.com/office/drawing/2014/main" id="{34BC1C86-53C9-530F-D254-DABF3AFD6DF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749"/>
          <a:stretch/>
        </p:blipFill>
        <p:spPr>
          <a:xfrm>
            <a:off x="4734310" y="1371554"/>
            <a:ext cx="1570074" cy="1476000"/>
          </a:xfrm>
          <a:prstGeom prst="rect">
            <a:avLst/>
          </a:prstGeom>
        </p:spPr>
      </p:pic>
      <p:pic>
        <p:nvPicPr>
          <p:cNvPr id="33" name="Imagen 32" descr="Gráfico, Gráfico de dispersión, Gráfico de cajas y bigotes&#10;&#10;Descripción generada automáticamente">
            <a:extLst>
              <a:ext uri="{FF2B5EF4-FFF2-40B4-BE49-F238E27FC236}">
                <a16:creationId xmlns:a16="http://schemas.microsoft.com/office/drawing/2014/main" id="{F5B74F0F-AAC8-3B90-1173-7409111610DE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7468" y="1276304"/>
            <a:ext cx="2097343" cy="1908000"/>
          </a:xfrm>
          <a:prstGeom prst="rect">
            <a:avLst/>
          </a:prstGeom>
        </p:spPr>
      </p:pic>
      <p:sp>
        <p:nvSpPr>
          <p:cNvPr id="8" name="28 CuadroTexto">
            <a:extLst>
              <a:ext uri="{FF2B5EF4-FFF2-40B4-BE49-F238E27FC236}">
                <a16:creationId xmlns:a16="http://schemas.microsoft.com/office/drawing/2014/main" id="{68F505BD-99E9-58C8-CEA6-6DBEC8104FAD}"/>
              </a:ext>
            </a:extLst>
          </p:cNvPr>
          <p:cNvSpPr txBox="1"/>
          <p:nvPr/>
        </p:nvSpPr>
        <p:spPr>
          <a:xfrm>
            <a:off x="558205" y="1004822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28 CuadroTexto">
            <a:extLst>
              <a:ext uri="{FF2B5EF4-FFF2-40B4-BE49-F238E27FC236}">
                <a16:creationId xmlns:a16="http://schemas.microsoft.com/office/drawing/2014/main" id="{49AB9B95-3C3F-E5FC-5C3D-D2EE67265677}"/>
              </a:ext>
            </a:extLst>
          </p:cNvPr>
          <p:cNvSpPr txBox="1"/>
          <p:nvPr/>
        </p:nvSpPr>
        <p:spPr>
          <a:xfrm>
            <a:off x="2720233" y="1002790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28 CuadroTexto">
            <a:extLst>
              <a:ext uri="{FF2B5EF4-FFF2-40B4-BE49-F238E27FC236}">
                <a16:creationId xmlns:a16="http://schemas.microsoft.com/office/drawing/2014/main" id="{BC6DA033-DF7D-3F56-325F-2CEEE89E376A}"/>
              </a:ext>
            </a:extLst>
          </p:cNvPr>
          <p:cNvSpPr txBox="1"/>
          <p:nvPr/>
        </p:nvSpPr>
        <p:spPr>
          <a:xfrm>
            <a:off x="4734310" y="1002790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Imagen 28">
            <a:extLst>
              <a:ext uri="{FF2B5EF4-FFF2-40B4-BE49-F238E27FC236}">
                <a16:creationId xmlns:a16="http://schemas.microsoft.com/office/drawing/2014/main" id="{0C1BE799-6D2F-8DB3-A8D3-1930E5C5957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27320" y="1001462"/>
            <a:ext cx="882000" cy="360567"/>
          </a:xfrm>
          <a:prstGeom prst="rect">
            <a:avLst/>
          </a:prstGeom>
        </p:spPr>
      </p:pic>
      <p:sp>
        <p:nvSpPr>
          <p:cNvPr id="2" name="38 CuadroTexto">
            <a:extLst>
              <a:ext uri="{FF2B5EF4-FFF2-40B4-BE49-F238E27FC236}">
                <a16:creationId xmlns:a16="http://schemas.microsoft.com/office/drawing/2014/main" id="{AB6067C5-5871-5BA2-6ED9-3CD38731E1F9}"/>
              </a:ext>
            </a:extLst>
          </p:cNvPr>
          <p:cNvSpPr txBox="1"/>
          <p:nvPr/>
        </p:nvSpPr>
        <p:spPr>
          <a:xfrm>
            <a:off x="554881" y="641799"/>
            <a:ext cx="575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57AC9FF8-F79F-4C00-AB4E-63BD006E77CB}"/>
              </a:ext>
            </a:extLst>
          </p:cNvPr>
          <p:cNvSpPr txBox="1"/>
          <p:nvPr/>
        </p:nvSpPr>
        <p:spPr>
          <a:xfrm>
            <a:off x="564406" y="3305175"/>
            <a:ext cx="5744545" cy="1935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2. The presence and direct contact between autologous lesional epidermal cell suspension and CLA</a:t>
            </a:r>
            <a:r>
              <a:rPr lang="en-US" sz="105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mory T cells enhances IL-22 production through HLA class II-mediated presentation.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</a:t>
            </a:r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Epidermal cells, CLA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/−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mory T cells, and CLA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/−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Epi cocultures were left untreated or stimulated with HDM, and IL-22 (</a:t>
            </a:r>
            <a:r>
              <a:rPr lang="en-US" sz="105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g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mL) was measured at day 5 (n=6). (</a:t>
            </a:r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HLA class I and II were blocked in CLA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/−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Epi cocultures on day 0, and IL-22 levels (</a:t>
            </a:r>
            <a:r>
              <a:rPr lang="en-US" sz="105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g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mL) were compared to isotype values on day 5 (n=6). (</a:t>
            </a:r>
            <a:r>
              <a:rPr lang="en-US" sz="105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Epidermal cells and HDM-stimulated CLA</a:t>
            </a:r>
            <a:r>
              <a:rPr lang="en-US" sz="105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/−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T cells were added in the lower and upper chamber of the </a:t>
            </a:r>
            <a:r>
              <a:rPr lang="en-US" sz="105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transwell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late, respectively, or cocultured together, and IL-22 (</a:t>
            </a:r>
            <a:r>
              <a:rPr lang="en-US" sz="105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pg</a:t>
            </a:r>
            <a:r>
              <a:rPr lang="en-US" sz="105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mL) was quantified on day 5 (n=4). CLA, cutaneous lymphocyte-associated antigen T cells; Epi, epidermal cell suspension; HDM, house dust mite; M, untreated; HLA, human leukocyte antigens. ns p &gt;.05; *p &lt;.05.</a:t>
            </a:r>
            <a:endParaRPr lang="es-ES" sz="105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065451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28 CuadroTexto">
            <a:extLst>
              <a:ext uri="{FF2B5EF4-FFF2-40B4-BE49-F238E27FC236}">
                <a16:creationId xmlns:a16="http://schemas.microsoft.com/office/drawing/2014/main" id="{542232DE-2DB2-2CCD-E913-4EF87EC729ED}"/>
              </a:ext>
            </a:extLst>
          </p:cNvPr>
          <p:cNvSpPr txBox="1"/>
          <p:nvPr/>
        </p:nvSpPr>
        <p:spPr>
          <a:xfrm>
            <a:off x="831381" y="985772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28 CuadroTexto">
            <a:extLst>
              <a:ext uri="{FF2B5EF4-FFF2-40B4-BE49-F238E27FC236}">
                <a16:creationId xmlns:a16="http://schemas.microsoft.com/office/drawing/2014/main" id="{692A8C50-4E9C-8A94-5DB7-89CA9E15291A}"/>
              </a:ext>
            </a:extLst>
          </p:cNvPr>
          <p:cNvSpPr txBox="1"/>
          <p:nvPr/>
        </p:nvSpPr>
        <p:spPr>
          <a:xfrm>
            <a:off x="3793630" y="985772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38 CuadroTexto">
            <a:extLst>
              <a:ext uri="{FF2B5EF4-FFF2-40B4-BE49-F238E27FC236}">
                <a16:creationId xmlns:a16="http://schemas.microsoft.com/office/drawing/2014/main" id="{2DFAD6F8-6F86-07E5-BCFC-4D0CDBEF5E7C}"/>
              </a:ext>
            </a:extLst>
          </p:cNvPr>
          <p:cNvSpPr txBox="1"/>
          <p:nvPr/>
        </p:nvSpPr>
        <p:spPr>
          <a:xfrm>
            <a:off x="554881" y="641799"/>
            <a:ext cx="575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CuadroTexto 19">
            <a:extLst>
              <a:ext uri="{FF2B5EF4-FFF2-40B4-BE49-F238E27FC236}">
                <a16:creationId xmlns:a16="http://schemas.microsoft.com/office/drawing/2014/main" id="{779F2547-16D3-319C-712F-D14A74E6CD9C}"/>
              </a:ext>
            </a:extLst>
          </p:cNvPr>
          <p:cNvSpPr txBox="1"/>
          <p:nvPr/>
        </p:nvSpPr>
        <p:spPr>
          <a:xfrm>
            <a:off x="564406" y="7782792"/>
            <a:ext cx="5744545" cy="184787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3. The degree of epidermal thickness does not differ between AD patients when stratified according to the presence or the absence of IL-4, IL-13 and IL-17A in vitro response to HDM.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D patients were stratified according to HDM-stimulated CLA</a:t>
            </a:r>
            <a:r>
              <a:rPr lang="en-US" sz="10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+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mory T-cell-derived (top) IL-4 production into IL4P (n=28) and IL4NP (n=30), (middle) IL-13 production into IL13P (n=31) and IL13NP (n=19), and (bottom) IL-17A production into IL17P (n=35) and IL17NP (n=23).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Epidermal thickness (µm) was compared between (top) IL4P (n=16), IL4NP (n=12) and controls (n=4), (middle) IL13P (n=21), IL13NP (n=7) and controls (n=4), and (bottom) IL17P (n=20), IL17NP (n=8) and controls (n=4). AD, atopic dermatitis; C, control subjects; CLA, cutaneous lymphocyte-associated antigen T cells; Epi, epidermal cell suspension; HDM, house dust mite; M, untreated; NP, non-producer; P, producer. ns p &gt; .05; *p &lt;.05; **p &lt;.01.</a:t>
            </a:r>
            <a:endParaRPr lang="es-ES" sz="10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Imagen 2" descr="Imagen de la pantalla de un celular con letras&#10;&#10;El contenido generado por IA puede ser incorrecto.">
            <a:extLst>
              <a:ext uri="{FF2B5EF4-FFF2-40B4-BE49-F238E27FC236}">
                <a16:creationId xmlns:a16="http://schemas.microsoft.com/office/drawing/2014/main" id="{353DC8FC-13A4-6F0E-6927-1BCB01F2906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103"/>
          <a:stretch/>
        </p:blipFill>
        <p:spPr>
          <a:xfrm>
            <a:off x="1246685" y="1009090"/>
            <a:ext cx="2541450" cy="2196000"/>
          </a:xfrm>
          <a:prstGeom prst="rect">
            <a:avLst/>
          </a:prstGeom>
        </p:spPr>
      </p:pic>
      <p:pic>
        <p:nvPicPr>
          <p:cNvPr id="5" name="Imagen 4" descr="Diagrama&#10;&#10;El contenido generado por IA puede ser incorrecto.">
            <a:extLst>
              <a:ext uri="{FF2B5EF4-FFF2-40B4-BE49-F238E27FC236}">
                <a16:creationId xmlns:a16="http://schemas.microsoft.com/office/drawing/2014/main" id="{52C45114-0096-8515-966D-8CAA84898A7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49"/>
          <a:stretch/>
        </p:blipFill>
        <p:spPr>
          <a:xfrm>
            <a:off x="1246686" y="3264723"/>
            <a:ext cx="2541450" cy="2196000"/>
          </a:xfrm>
          <a:prstGeom prst="rect">
            <a:avLst/>
          </a:prstGeom>
        </p:spPr>
      </p:pic>
      <p:pic>
        <p:nvPicPr>
          <p:cNvPr id="7" name="Imagen 6" descr="Diagrama&#10;&#10;El contenido generado por IA puede ser incorrecto.">
            <a:extLst>
              <a:ext uri="{FF2B5EF4-FFF2-40B4-BE49-F238E27FC236}">
                <a16:creationId xmlns:a16="http://schemas.microsoft.com/office/drawing/2014/main" id="{7CBD8A1E-4792-5D39-40B1-9070E4C9CBA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766"/>
          <a:stretch/>
        </p:blipFill>
        <p:spPr>
          <a:xfrm>
            <a:off x="1246686" y="5520356"/>
            <a:ext cx="2541449" cy="2196000"/>
          </a:xfrm>
          <a:prstGeom prst="rect">
            <a:avLst/>
          </a:prstGeom>
        </p:spPr>
      </p:pic>
      <p:pic>
        <p:nvPicPr>
          <p:cNvPr id="9" name="Imagen 8" descr="Gráfico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80E21658-C01C-4DA9-727B-182F940A1DB2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993"/>
          <a:stretch/>
        </p:blipFill>
        <p:spPr>
          <a:xfrm>
            <a:off x="4165105" y="1287579"/>
            <a:ext cx="1689785" cy="1764000"/>
          </a:xfrm>
          <a:prstGeom prst="rect">
            <a:avLst/>
          </a:prstGeom>
        </p:spPr>
      </p:pic>
      <p:pic>
        <p:nvPicPr>
          <p:cNvPr id="21" name="Imagen 20" descr="Gráfico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58C27CCB-32E0-FDD6-2842-9A9929B55A7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672"/>
          <a:stretch/>
        </p:blipFill>
        <p:spPr>
          <a:xfrm>
            <a:off x="4165105" y="3554424"/>
            <a:ext cx="1689785" cy="1764000"/>
          </a:xfrm>
          <a:prstGeom prst="rect">
            <a:avLst/>
          </a:prstGeom>
        </p:spPr>
      </p:pic>
      <p:pic>
        <p:nvPicPr>
          <p:cNvPr id="23" name="Imagen 22" descr="Gráfico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4DE86317-C3B0-8589-B9F1-7B083044A1F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9672"/>
          <a:stretch/>
        </p:blipFill>
        <p:spPr>
          <a:xfrm>
            <a:off x="4165105" y="5801007"/>
            <a:ext cx="1689785" cy="176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699748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38 CuadroTexto">
            <a:extLst>
              <a:ext uri="{FF2B5EF4-FFF2-40B4-BE49-F238E27FC236}">
                <a16:creationId xmlns:a16="http://schemas.microsoft.com/office/drawing/2014/main" id="{D3031747-3D07-3D47-D139-77F915C622B6}"/>
              </a:ext>
            </a:extLst>
          </p:cNvPr>
          <p:cNvSpPr txBox="1"/>
          <p:nvPr/>
        </p:nvSpPr>
        <p:spPr>
          <a:xfrm>
            <a:off x="554881" y="641799"/>
            <a:ext cx="57540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28 CuadroTexto">
            <a:extLst>
              <a:ext uri="{FF2B5EF4-FFF2-40B4-BE49-F238E27FC236}">
                <a16:creationId xmlns:a16="http://schemas.microsoft.com/office/drawing/2014/main" id="{8A4D5A20-FA8B-03FF-EA60-5485F863A5F4}"/>
              </a:ext>
            </a:extLst>
          </p:cNvPr>
          <p:cNvSpPr txBox="1"/>
          <p:nvPr/>
        </p:nvSpPr>
        <p:spPr>
          <a:xfrm>
            <a:off x="1376548" y="1005023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28 CuadroTexto">
            <a:extLst>
              <a:ext uri="{FF2B5EF4-FFF2-40B4-BE49-F238E27FC236}">
                <a16:creationId xmlns:a16="http://schemas.microsoft.com/office/drawing/2014/main" id="{008DC50C-2F4F-FCBE-CE18-790DF7B46211}"/>
              </a:ext>
            </a:extLst>
          </p:cNvPr>
          <p:cNvSpPr txBox="1"/>
          <p:nvPr/>
        </p:nvSpPr>
        <p:spPr>
          <a:xfrm>
            <a:off x="3810394" y="1002991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28 CuadroTexto">
            <a:extLst>
              <a:ext uri="{FF2B5EF4-FFF2-40B4-BE49-F238E27FC236}">
                <a16:creationId xmlns:a16="http://schemas.microsoft.com/office/drawing/2014/main" id="{AE37D997-F8F0-479D-3DCF-FAC02C1D494B}"/>
              </a:ext>
            </a:extLst>
          </p:cNvPr>
          <p:cNvSpPr txBox="1"/>
          <p:nvPr/>
        </p:nvSpPr>
        <p:spPr>
          <a:xfrm>
            <a:off x="1369730" y="3524853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28 CuadroTexto">
            <a:extLst>
              <a:ext uri="{FF2B5EF4-FFF2-40B4-BE49-F238E27FC236}">
                <a16:creationId xmlns:a16="http://schemas.microsoft.com/office/drawing/2014/main" id="{30BF3544-16BE-24EF-9286-BB52B33FB246}"/>
              </a:ext>
            </a:extLst>
          </p:cNvPr>
          <p:cNvSpPr txBox="1"/>
          <p:nvPr/>
        </p:nvSpPr>
        <p:spPr>
          <a:xfrm>
            <a:off x="3840738" y="3524853"/>
            <a:ext cx="39495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00" b="1" dirty="0">
                <a:latin typeface="Arial" panose="020B0604020202020204" pitchFamily="34" charset="0"/>
                <a:cs typeface="Arial" panose="020B0604020202020204" pitchFamily="34" charset="0"/>
              </a:rPr>
              <a:t>(D)</a:t>
            </a:r>
            <a:endParaRPr lang="en-GB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6A1E24DF-2762-B659-1297-780BD4343D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4255" y="1010247"/>
            <a:ext cx="628650" cy="380114"/>
          </a:xfrm>
          <a:prstGeom prst="rect">
            <a:avLst/>
          </a:prstGeom>
        </p:spPr>
      </p:pic>
      <p:sp>
        <p:nvSpPr>
          <p:cNvPr id="2" name="CuadroTexto 1">
            <a:extLst>
              <a:ext uri="{FF2B5EF4-FFF2-40B4-BE49-F238E27FC236}">
                <a16:creationId xmlns:a16="http://schemas.microsoft.com/office/drawing/2014/main" id="{D0E9DD85-B613-14D3-72AB-2FDBDA0CBAA9}"/>
              </a:ext>
            </a:extLst>
          </p:cNvPr>
          <p:cNvSpPr txBox="1"/>
          <p:nvPr/>
        </p:nvSpPr>
        <p:spPr>
          <a:xfrm>
            <a:off x="564406" y="5430117"/>
            <a:ext cx="5744545" cy="16709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Figure S4. The CLA</a:t>
            </a:r>
            <a:r>
              <a:rPr lang="en-US" sz="1000" b="1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−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mory T-cell IL-22 response triggered by HDM does not stratify patients with distinct degree of epidermal thickness nor specific </a:t>
            </a:r>
            <a:r>
              <a:rPr lang="en-US" sz="1000" b="1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gE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plasma levels. 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A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AD patients were stratified according to IL-22 production by HDM-stimulated CLA</a:t>
            </a:r>
            <a:r>
              <a:rPr lang="en-US" sz="1000" kern="100" baseline="300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−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memory T cells (IL22P (n=1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4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, IL22NP (n=44)).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B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Epidermal thickness (µm) was compared between IL22P (n=7), IL22NP (n=21) and controls (n=4). Plasma levels of specific </a:t>
            </a:r>
            <a:r>
              <a:rPr lang="en-US" sz="10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IgE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 against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C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HDM (OD) and (</a:t>
            </a:r>
            <a:r>
              <a:rPr lang="en-US" sz="1000" b="1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D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) SEB (</a:t>
            </a:r>
            <a:r>
              <a:rPr lang="en-US" sz="1000" kern="100" dirty="0" err="1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kU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/L) were compared between IL22P (n=13-14), IL22NP (n=</a:t>
            </a:r>
            <a:r>
              <a:rPr lang="en-US" sz="1000" kern="100" dirty="0"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39</a:t>
            </a:r>
            <a:r>
              <a:rPr lang="en-US" sz="1000" kern="100" dirty="0">
                <a:effectLst/>
                <a:latin typeface="Times New Roman" panose="02020603050405020304" pitchFamily="18" charset="0"/>
                <a:ea typeface="Aptos" panose="020B0004020202020204" pitchFamily="34" charset="0"/>
                <a:cs typeface="Times New Roman" panose="02020603050405020304" pitchFamily="18" charset="0"/>
              </a:rPr>
              <a:t>-44) and controls (n=17). AD, atopic dermatitis; C, control subjects; CLA, cutaneous lymphocyte-associated antigen T cells; Epi, epidermal cell suspension; HDM, house dust mite; M, untreated; OD, optical density; SEB, staphylococcal enterotoxin B. ns p &gt;.05; *p &lt;.05; ***p &lt;.001; ****p &lt;.0001.</a:t>
            </a:r>
            <a:endParaRPr lang="es-ES" sz="1000" kern="100" dirty="0">
              <a:effectLst/>
              <a:latin typeface="Times New Roman" panose="02020603050405020304" pitchFamily="18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Imagen 6" descr="Gráfico&#10;&#10;El contenido generado por IA puede ser incorrecto.">
            <a:extLst>
              <a:ext uri="{FF2B5EF4-FFF2-40B4-BE49-F238E27FC236}">
                <a16:creationId xmlns:a16="http://schemas.microsoft.com/office/drawing/2014/main" id="{DA77DC7F-E28D-B4DD-52CB-58D8BD28269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005"/>
          <a:stretch/>
        </p:blipFill>
        <p:spPr>
          <a:xfrm>
            <a:off x="1369730" y="1393964"/>
            <a:ext cx="2283175" cy="2016000"/>
          </a:xfrm>
          <a:prstGeom prst="rect">
            <a:avLst/>
          </a:prstGeom>
        </p:spPr>
      </p:pic>
      <p:pic>
        <p:nvPicPr>
          <p:cNvPr id="10" name="Imagen 9" descr="Gráfico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C07C1050-DE87-7449-2B39-99B324679A0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394" y="1704259"/>
            <a:ext cx="1666671" cy="1566000"/>
          </a:xfrm>
          <a:prstGeom prst="rect">
            <a:avLst/>
          </a:prstGeom>
        </p:spPr>
      </p:pic>
      <p:pic>
        <p:nvPicPr>
          <p:cNvPr id="12" name="Imagen 11" descr="Diagrama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C738A923-A686-3351-ED44-1C74AF7ED17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69730" y="3777617"/>
            <a:ext cx="1753696" cy="1566000"/>
          </a:xfrm>
          <a:prstGeom prst="rect">
            <a:avLst/>
          </a:prstGeom>
        </p:spPr>
      </p:pic>
      <p:pic>
        <p:nvPicPr>
          <p:cNvPr id="15" name="Imagen 14" descr="Gráfico, Gráfico de cajas y bigotes&#10;&#10;El contenido generado por IA puede ser incorrecto.">
            <a:extLst>
              <a:ext uri="{FF2B5EF4-FFF2-40B4-BE49-F238E27FC236}">
                <a16:creationId xmlns:a16="http://schemas.microsoft.com/office/drawing/2014/main" id="{F029C5A1-3907-1CE5-9957-AA1129260444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0738" y="3777617"/>
            <a:ext cx="1647533" cy="156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630105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e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70</TotalTime>
  <Words>756</Words>
  <Application>Microsoft Office PowerPoint</Application>
  <PresentationFormat>A4 (210 x 297 mm)</PresentationFormat>
  <Paragraphs>17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9" baseType="lpstr">
      <vt:lpstr>Aptos</vt:lpstr>
      <vt:lpstr>Aptos Display</vt:lpstr>
      <vt:lpstr>Arial</vt:lpstr>
      <vt:lpstr>Times New Roman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Irene García Jiménez</dc:creator>
  <cp:lastModifiedBy>Irene García Jiménez</cp:lastModifiedBy>
  <cp:revision>27</cp:revision>
  <dcterms:created xsi:type="dcterms:W3CDTF">2024-11-27T14:42:31Z</dcterms:created>
  <dcterms:modified xsi:type="dcterms:W3CDTF">2025-05-19T12:57:01Z</dcterms:modified>
</cp:coreProperties>
</file>